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2" r:id="rId3"/>
    <p:sldId id="271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8" userDrawn="1">
          <p15:clr>
            <a:srgbClr val="A4A3A4"/>
          </p15:clr>
        </p15:guide>
        <p15:guide id="2" pos="52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994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876" y="114"/>
      </p:cViewPr>
      <p:guideLst>
        <p:guide orient="horz" pos="368"/>
        <p:guide pos="52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4112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9256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1732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2183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4554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1078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0775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0833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9079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96670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7094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F1E67-9EA6-4309-B3D3-11B064EE9F6D}" type="datetimeFigureOut">
              <a:rPr lang="ko-KR" altLang="en-US" smtClean="0"/>
              <a:t>2023-11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422E1-AF75-4A69-A9F6-FEE6E2CBF03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59862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f"/><Relationship Id="rId3" Type="http://schemas.openxmlformats.org/officeDocument/2006/relationships/image" Target="../media/image3.tiff"/><Relationship Id="rId7" Type="http://schemas.openxmlformats.org/officeDocument/2006/relationships/image" Target="../media/image7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10" Type="http://schemas.openxmlformats.org/officeDocument/2006/relationships/image" Target="../media/image10.tiff"/><Relationship Id="rId4" Type="http://schemas.openxmlformats.org/officeDocument/2006/relationships/image" Target="../media/image4.tiff"/><Relationship Id="rId9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tiff"/><Relationship Id="rId5" Type="http://schemas.openxmlformats.org/officeDocument/2006/relationships/image" Target="../media/image14.tiff"/><Relationship Id="rId10" Type="http://schemas.openxmlformats.org/officeDocument/2006/relationships/image" Target="../media/image19.tiff"/><Relationship Id="rId4" Type="http://schemas.openxmlformats.org/officeDocument/2006/relationships/image" Target="../media/image13.tiff"/><Relationship Id="rId9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CF2A3B82-8D84-4EE0-B0D9-CCB0489D0CF4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6097" y="1624330"/>
            <a:ext cx="6059805" cy="3609340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FEFC6BE-24C9-4C31-BF4C-31F2D16BC149}"/>
              </a:ext>
            </a:extLst>
          </p:cNvPr>
          <p:cNvSpPr txBox="1"/>
          <p:nvPr/>
        </p:nvSpPr>
        <p:spPr>
          <a:xfrm>
            <a:off x="3066097" y="5991880"/>
            <a:ext cx="688448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(A) UV chromatogram of LC/MS (detection wavelength was set as 254 nm) and (B) UV and MS data for 6-pentyl-α-pyrone (6PP). 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93367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229396" y="79979"/>
            <a:ext cx="7405055" cy="6280139"/>
            <a:chOff x="2229396" y="79979"/>
            <a:chExt cx="7405055" cy="6280139"/>
          </a:xfrm>
        </p:grpSpPr>
        <p:sp>
          <p:nvSpPr>
            <p:cNvPr id="17" name="TextBox 16"/>
            <p:cNvSpPr txBox="1"/>
            <p:nvPr/>
          </p:nvSpPr>
          <p:spPr>
            <a:xfrm>
              <a:off x="4456382" y="551021"/>
              <a:ext cx="47259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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241157" y="358620"/>
              <a:ext cx="51985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425894" y="556069"/>
              <a:ext cx="47259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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456382" y="342612"/>
              <a:ext cx="47259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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426582" y="347660"/>
              <a:ext cx="472593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+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241157" y="2413255"/>
              <a:ext cx="51985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CB014C3-B48C-42D6-B256-D60F5EF94E2F}"/>
                </a:ext>
              </a:extLst>
            </p:cNvPr>
            <p:cNvSpPr txBox="1"/>
            <p:nvPr/>
          </p:nvSpPr>
          <p:spPr>
            <a:xfrm>
              <a:off x="5609350" y="79979"/>
              <a:ext cx="200934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Raw264.7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직선 연결선 23"/>
            <p:cNvCxnSpPr/>
            <p:nvPr/>
          </p:nvCxnSpPr>
          <p:spPr>
            <a:xfrm flipH="1">
              <a:off x="3786538" y="349386"/>
              <a:ext cx="5580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A2B476AE-9F18-4E2B-BF73-BAA444A41BA2}"/>
                </a:ext>
              </a:extLst>
            </p:cNvPr>
            <p:cNvSpPr txBox="1"/>
            <p:nvPr/>
          </p:nvSpPr>
          <p:spPr>
            <a:xfrm>
              <a:off x="2238104" y="581799"/>
              <a:ext cx="17018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98000"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      6PP (200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2B476AE-9F18-4E2B-BF73-BAA444A41BA2}"/>
                </a:ext>
              </a:extLst>
            </p:cNvPr>
            <p:cNvSpPr txBox="1"/>
            <p:nvPr/>
          </p:nvSpPr>
          <p:spPr>
            <a:xfrm>
              <a:off x="2229396" y="373390"/>
              <a:ext cx="17018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198000" algn="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LPS (0.5 </a:t>
              </a:r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μg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그림 4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6232" y="2717182"/>
              <a:ext cx="1800000" cy="1800000"/>
            </a:xfrm>
            <a:prstGeom prst="rect">
              <a:avLst/>
            </a:prstGeom>
          </p:spPr>
        </p:pic>
        <p:pic>
          <p:nvPicPr>
            <p:cNvPr id="46" name="그림 4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6232" y="4560118"/>
              <a:ext cx="1800000" cy="1800000"/>
            </a:xfrm>
            <a:prstGeom prst="rect">
              <a:avLst/>
            </a:prstGeom>
          </p:spPr>
        </p:pic>
        <p:pic>
          <p:nvPicPr>
            <p:cNvPr id="47" name="그림 4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9350" y="2717182"/>
              <a:ext cx="1800000" cy="1800000"/>
            </a:xfrm>
            <a:prstGeom prst="rect">
              <a:avLst/>
            </a:prstGeom>
          </p:spPr>
        </p:pic>
        <p:pic>
          <p:nvPicPr>
            <p:cNvPr id="49" name="그림 4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9350" y="4558547"/>
              <a:ext cx="1800000" cy="1800000"/>
            </a:xfrm>
            <a:prstGeom prst="rect">
              <a:avLst/>
            </a:prstGeom>
          </p:spPr>
        </p:pic>
        <p:pic>
          <p:nvPicPr>
            <p:cNvPr id="50" name="그림 49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2791" y="4558547"/>
              <a:ext cx="1800000" cy="1800000"/>
            </a:xfrm>
            <a:prstGeom prst="rect">
              <a:avLst/>
            </a:prstGeom>
          </p:spPr>
        </p:pic>
        <p:pic>
          <p:nvPicPr>
            <p:cNvPr id="51" name="그림 5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2791" y="2717182"/>
              <a:ext cx="1800000" cy="1800000"/>
            </a:xfrm>
            <a:prstGeom prst="rect">
              <a:avLst/>
            </a:prstGeom>
          </p:spPr>
        </p:pic>
        <p:pic>
          <p:nvPicPr>
            <p:cNvPr id="45" name="그림 4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6232" y="878659"/>
              <a:ext cx="1800000" cy="1800000"/>
            </a:xfrm>
            <a:prstGeom prst="rect">
              <a:avLst/>
            </a:prstGeom>
          </p:spPr>
        </p:pic>
        <p:pic>
          <p:nvPicPr>
            <p:cNvPr id="48" name="그림 4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09350" y="878659"/>
              <a:ext cx="1800000" cy="1800000"/>
            </a:xfrm>
            <a:prstGeom prst="rect">
              <a:avLst/>
            </a:prstGeom>
          </p:spPr>
        </p:pic>
        <p:pic>
          <p:nvPicPr>
            <p:cNvPr id="52" name="그림 5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92791" y="878659"/>
              <a:ext cx="1800000" cy="1800000"/>
            </a:xfrm>
            <a:prstGeom prst="rect">
              <a:avLst/>
            </a:prstGeom>
          </p:spPr>
        </p:pic>
        <p:cxnSp>
          <p:nvCxnSpPr>
            <p:cNvPr id="55" name="직선 연결선 54"/>
            <p:cNvCxnSpPr/>
            <p:nvPr/>
          </p:nvCxnSpPr>
          <p:spPr>
            <a:xfrm>
              <a:off x="7363666" y="2627639"/>
              <a:ext cx="10706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9245312" y="2627639"/>
              <a:ext cx="10706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>
              <a:off x="5481557" y="2627639"/>
              <a:ext cx="10706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직사각형 30"/>
            <p:cNvSpPr/>
            <p:nvPr/>
          </p:nvSpPr>
          <p:spPr>
            <a:xfrm>
              <a:off x="8384441" y="1650366"/>
              <a:ext cx="360000" cy="360000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6316753" y="1264436"/>
              <a:ext cx="360000" cy="360000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4903411" y="918505"/>
              <a:ext cx="360000" cy="360000"/>
            </a:xfrm>
            <a:prstGeom prst="rect">
              <a:avLst/>
            </a:prstGeom>
            <a:noFill/>
            <a:ln w="1905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2734959" y="1652081"/>
              <a:ext cx="1792800" cy="2769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d</a:t>
              </a:r>
              <a:endParaRPr lang="ko-KR" altLang="en-US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2736285" y="3482966"/>
              <a:ext cx="1792800" cy="2769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rf2</a:t>
              </a:r>
              <a:endParaRPr lang="ko-KR" alt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2737612" y="5322557"/>
              <a:ext cx="1792800" cy="276999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ucleus</a:t>
              </a:r>
              <a:endParaRPr lang="ko-KR" altLang="en-US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245508" y="563272"/>
              <a:ext cx="519852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직사각형 1"/>
            <p:cNvSpPr/>
            <p:nvPr/>
          </p:nvSpPr>
          <p:spPr>
            <a:xfrm>
              <a:off x="9476509" y="373390"/>
              <a:ext cx="157942" cy="598406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34" name="TextBox 33">
            <a:extLst>
              <a:ext uri="{FF2B5EF4-FFF2-40B4-BE49-F238E27FC236}">
                <a16:creationId xmlns:a16="http://schemas.microsoft.com/office/drawing/2014/main" id="{AFAEA738-E2AE-48E0-93D3-8C9DAEB2A79F}"/>
              </a:ext>
            </a:extLst>
          </p:cNvPr>
          <p:cNvSpPr txBox="1"/>
          <p:nvPr/>
        </p:nvSpPr>
        <p:spPr>
          <a:xfrm>
            <a:off x="3213098" y="6457706"/>
            <a:ext cx="632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ffect of 6PP on the nucleus translocation of Nrf2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9239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7" name="직선 연결선 16"/>
          <p:cNvCxnSpPr/>
          <p:nvPr/>
        </p:nvCxnSpPr>
        <p:spPr>
          <a:xfrm flipH="1">
            <a:off x="3683463" y="438019"/>
            <a:ext cx="550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366589" y="438019"/>
            <a:ext cx="47259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8035850" y="445341"/>
            <a:ext cx="51985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241703" y="445092"/>
            <a:ext cx="47259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365077" y="625521"/>
            <a:ext cx="47259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241703" y="631080"/>
            <a:ext cx="47259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8034338" y="647706"/>
            <a:ext cx="519852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CB014C3-B48C-42D6-B256-D60F5EF94E2F}"/>
              </a:ext>
            </a:extLst>
          </p:cNvPr>
          <p:cNvSpPr txBox="1"/>
          <p:nvPr/>
        </p:nvSpPr>
        <p:spPr>
          <a:xfrm>
            <a:off x="5461108" y="169341"/>
            <a:ext cx="2009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aw264.7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2B476AE-9F18-4E2B-BF73-BAA444A41BA2}"/>
              </a:ext>
            </a:extLst>
          </p:cNvPr>
          <p:cNvSpPr txBox="1"/>
          <p:nvPr/>
        </p:nvSpPr>
        <p:spPr>
          <a:xfrm>
            <a:off x="2103120" y="616259"/>
            <a:ext cx="1703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98000" algn="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     6PP (200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909" y="4574536"/>
            <a:ext cx="1800000" cy="1800000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909" y="2752751"/>
            <a:ext cx="1800000" cy="1800000"/>
          </a:xfrm>
          <a:prstGeom prst="rect">
            <a:avLst/>
          </a:prstGeom>
        </p:spPr>
      </p:pic>
      <p:pic>
        <p:nvPicPr>
          <p:cNvPr id="30" name="그림 2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2909" y="934010"/>
            <a:ext cx="1800000" cy="1800000"/>
          </a:xfrm>
          <a:prstGeom prst="rect">
            <a:avLst/>
          </a:prstGeom>
        </p:spPr>
      </p:pic>
      <p:pic>
        <p:nvPicPr>
          <p:cNvPr id="31" name="그림 3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8016" y="934010"/>
            <a:ext cx="1800000" cy="1800000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52283" y="4574536"/>
            <a:ext cx="1800000" cy="1800000"/>
          </a:xfrm>
          <a:prstGeom prst="rect">
            <a:avLst/>
          </a:prstGeom>
        </p:spPr>
      </p:pic>
      <p:pic>
        <p:nvPicPr>
          <p:cNvPr id="33" name="그림 3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6473" y="2752751"/>
            <a:ext cx="1800000" cy="1800000"/>
          </a:xfrm>
          <a:prstGeom prst="rect">
            <a:avLst/>
          </a:prstGeom>
        </p:spPr>
      </p:pic>
      <p:pic>
        <p:nvPicPr>
          <p:cNvPr id="37" name="그림 3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925" y="2752751"/>
            <a:ext cx="1800000" cy="1800000"/>
          </a:xfrm>
          <a:prstGeom prst="rect">
            <a:avLst/>
          </a:prstGeom>
        </p:spPr>
      </p:pic>
      <p:pic>
        <p:nvPicPr>
          <p:cNvPr id="38" name="그림 37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925" y="930966"/>
            <a:ext cx="1800000" cy="1800000"/>
          </a:xfrm>
          <a:prstGeom prst="rect">
            <a:avLst/>
          </a:prstGeom>
        </p:spPr>
      </p:pic>
      <p:pic>
        <p:nvPicPr>
          <p:cNvPr id="39" name="그림 38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00925" y="4574536"/>
            <a:ext cx="1800000" cy="1800000"/>
          </a:xfrm>
          <a:prstGeom prst="rect">
            <a:avLst/>
          </a:prstGeom>
        </p:spPr>
      </p:pic>
      <p:sp>
        <p:nvSpPr>
          <p:cNvPr id="45" name="직사각형 44"/>
          <p:cNvSpPr/>
          <p:nvPr/>
        </p:nvSpPr>
        <p:spPr>
          <a:xfrm>
            <a:off x="4408369" y="1614425"/>
            <a:ext cx="432643" cy="432643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4" name="직사각형 53"/>
          <p:cNvSpPr/>
          <p:nvPr/>
        </p:nvSpPr>
        <p:spPr>
          <a:xfrm>
            <a:off x="6332231" y="1790300"/>
            <a:ext cx="432643" cy="432643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6" name="직사각형 55"/>
          <p:cNvSpPr/>
          <p:nvPr/>
        </p:nvSpPr>
        <p:spPr>
          <a:xfrm>
            <a:off x="8075977" y="1732728"/>
            <a:ext cx="432643" cy="432643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46" name="직선 연결선 45"/>
          <p:cNvCxnSpPr/>
          <p:nvPr/>
        </p:nvCxnSpPr>
        <p:spPr>
          <a:xfrm>
            <a:off x="3837045" y="2631611"/>
            <a:ext cx="1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>
            <a:off x="5692646" y="2663430"/>
            <a:ext cx="1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7497174" y="2670130"/>
            <a:ext cx="108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 rot="16200000">
            <a:off x="2621745" y="1691268"/>
            <a:ext cx="1792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ko-KR" altLang="en-US" sz="1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2623071" y="3513444"/>
            <a:ext cx="1792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altLang="ko-K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/p65</a:t>
            </a:r>
            <a:endParaRPr lang="ko-KR" altLang="en-US" sz="12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2624398" y="5335617"/>
            <a:ext cx="1792800" cy="27699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endParaRPr lang="ko-KR" altLang="en-US" sz="12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직사각형 42"/>
          <p:cNvSpPr/>
          <p:nvPr/>
        </p:nvSpPr>
        <p:spPr>
          <a:xfrm>
            <a:off x="9260379" y="373390"/>
            <a:ext cx="157942" cy="59840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2B476AE-9F18-4E2B-BF73-BAA444A41BA2}"/>
              </a:ext>
            </a:extLst>
          </p:cNvPr>
          <p:cNvSpPr txBox="1"/>
          <p:nvPr/>
        </p:nvSpPr>
        <p:spPr>
          <a:xfrm>
            <a:off x="2105892" y="436155"/>
            <a:ext cx="1703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98000" algn="r"/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LPS (0.5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/mL)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DE975CC-E7F1-4004-A251-06F0A50DB3F8}"/>
              </a:ext>
            </a:extLst>
          </p:cNvPr>
          <p:cNvSpPr txBox="1"/>
          <p:nvPr/>
        </p:nvSpPr>
        <p:spPr>
          <a:xfrm>
            <a:off x="3264860" y="6457706"/>
            <a:ext cx="65180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400" b="1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Effect of 6PP on the nucleus translocation of NF-</a:t>
            </a:r>
            <a:r>
              <a:rPr lang="el-GR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9526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576</TotalTime>
  <Words>114</Words>
  <Application>Microsoft Office PowerPoint</Application>
  <PresentationFormat>Widescreen</PresentationFormat>
  <Paragraphs>2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맑은 고딕</vt:lpstr>
      <vt:lpstr>等线</vt:lpstr>
      <vt:lpstr>Arial</vt:lpstr>
      <vt:lpstr>Symbol</vt:lpstr>
      <vt:lpstr>Office 테마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76</cp:revision>
  <dcterms:created xsi:type="dcterms:W3CDTF">2023-03-02T08:28:55Z</dcterms:created>
  <dcterms:modified xsi:type="dcterms:W3CDTF">2023-11-22T02:07:14Z</dcterms:modified>
</cp:coreProperties>
</file>